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ulie Sappa" initials="JS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80E2794-8FDC-4116-A059-ACE76716EDAF}" v="1" dt="2019-09-09T10:18:23.35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8618" autoAdjust="0"/>
  </p:normalViewPr>
  <p:slideViewPr>
    <p:cSldViewPr>
      <p:cViewPr varScale="1">
        <p:scale>
          <a:sx n="107" d="100"/>
          <a:sy n="107" d="100"/>
        </p:scale>
        <p:origin x="-73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commentAuthors" Target="commentAuthors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lie Sappa" userId="bd83afab-e60e-4015-9371-2abb542399e5" providerId="ADAL" clId="{680E2794-8FDC-4116-A059-ACE76716EDAF}"/>
    <pc:docChg chg="custSel modSld">
      <pc:chgData name="Julie Sappa" userId="bd83afab-e60e-4015-9371-2abb542399e5" providerId="ADAL" clId="{680E2794-8FDC-4116-A059-ACE76716EDAF}" dt="2019-09-09T10:18:23.353" v="46"/>
      <pc:docMkLst>
        <pc:docMk/>
      </pc:docMkLst>
      <pc:sldChg chg="modSp addCm modCm">
        <pc:chgData name="Julie Sappa" userId="bd83afab-e60e-4015-9371-2abb542399e5" providerId="ADAL" clId="{680E2794-8FDC-4116-A059-ACE76716EDAF}" dt="2019-09-09T10:18:23.353" v="46"/>
        <pc:sldMkLst>
          <pc:docMk/>
          <pc:sldMk cId="4158856360" sldId="256"/>
        </pc:sldMkLst>
        <pc:spChg chg="mod">
          <ac:chgData name="Julie Sappa" userId="bd83afab-e60e-4015-9371-2abb542399e5" providerId="ADAL" clId="{680E2794-8FDC-4116-A059-ACE76716EDAF}" dt="2019-09-09T10:17:49.967" v="43" actId="20577"/>
          <ac:spMkLst>
            <pc:docMk/>
            <pc:sldMk cId="4158856360" sldId="256"/>
            <ac:spMk id="17" creationId="{00000000-0000-0000-0000-000000000000}"/>
          </ac:spMkLst>
        </pc:spChg>
        <pc:spChg chg="mod">
          <ac:chgData name="Julie Sappa" userId="bd83afab-e60e-4015-9371-2abb542399e5" providerId="ADAL" clId="{680E2794-8FDC-4116-A059-ACE76716EDAF}" dt="2019-09-09T10:17:59.850" v="44" actId="20577"/>
          <ac:spMkLst>
            <pc:docMk/>
            <pc:sldMk cId="4158856360" sldId="256"/>
            <ac:spMk id="26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1F465-30E2-46B0-A3A9-D30B0E5F1E4E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9500D-43DA-4C83-9B6D-8342826B33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4713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1F465-30E2-46B0-A3A9-D30B0E5F1E4E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9500D-43DA-4C83-9B6D-8342826B33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31633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1F465-30E2-46B0-A3A9-D30B0E5F1E4E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9500D-43DA-4C83-9B6D-8342826B33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6278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1F465-30E2-46B0-A3A9-D30B0E5F1E4E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9500D-43DA-4C83-9B6D-8342826B33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5635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1F465-30E2-46B0-A3A9-D30B0E5F1E4E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9500D-43DA-4C83-9B6D-8342826B33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44045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1F465-30E2-46B0-A3A9-D30B0E5F1E4E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9500D-43DA-4C83-9B6D-8342826B33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5163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1F465-30E2-46B0-A3A9-D30B0E5F1E4E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9500D-43DA-4C83-9B6D-8342826B33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1016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1F465-30E2-46B0-A3A9-D30B0E5F1E4E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9500D-43DA-4C83-9B6D-8342826B33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6302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1F465-30E2-46B0-A3A9-D30B0E5F1E4E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9500D-43DA-4C83-9B6D-8342826B33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791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1F465-30E2-46B0-A3A9-D30B0E5F1E4E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9500D-43DA-4C83-9B6D-8342826B33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0894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1F465-30E2-46B0-A3A9-D30B0E5F1E4E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9500D-43DA-4C83-9B6D-8342826B33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276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C1F465-30E2-46B0-A3A9-D30B0E5F1E4E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29500D-43DA-4C83-9B6D-8342826B33B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7768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Tableau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8001817"/>
              </p:ext>
            </p:extLst>
          </p:nvPr>
        </p:nvGraphicFramePr>
        <p:xfrm>
          <a:off x="8093025" y="769338"/>
          <a:ext cx="943471" cy="992505"/>
        </p:xfrm>
        <a:graphic>
          <a:graphicData uri="http://schemas.openxmlformats.org/drawingml/2006/table">
            <a:tbl>
              <a:tblPr/>
              <a:tblGrid>
                <a:gridCol w="360040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72008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72008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34925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37083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72008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34925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  <a:gridCol w="85599">
                  <a:extLst>
                    <a:ext uri="{9D8B030D-6E8A-4147-A177-3AD203B41FA5}">
                      <a16:colId xmlns="" xmlns:a16="http://schemas.microsoft.com/office/drawing/2014/main" val="20007"/>
                    </a:ext>
                  </a:extLst>
                </a:gridCol>
                <a:gridCol w="95500">
                  <a:extLst>
                    <a:ext uri="{9D8B030D-6E8A-4147-A177-3AD203B41FA5}">
                      <a16:colId xmlns="" xmlns:a16="http://schemas.microsoft.com/office/drawing/2014/main" val="20008"/>
                    </a:ext>
                  </a:extLst>
                </a:gridCol>
                <a:gridCol w="34925">
                  <a:extLst>
                    <a:ext uri="{9D8B030D-6E8A-4147-A177-3AD203B41FA5}">
                      <a16:colId xmlns="" xmlns:a16="http://schemas.microsoft.com/office/drawing/2014/main" val="20009"/>
                    </a:ext>
                  </a:extLst>
                </a:gridCol>
                <a:gridCol w="44450">
                  <a:extLst>
                    <a:ext uri="{9D8B030D-6E8A-4147-A177-3AD203B41FA5}">
                      <a16:colId xmlns="" xmlns:a16="http://schemas.microsoft.com/office/drawing/2014/main" val="20010"/>
                    </a:ext>
                  </a:extLst>
                </a:gridCol>
              </a:tblGrid>
              <a:tr h="1568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cor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9C78E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AC78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1D1A3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1D1A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D3A8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568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10"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9         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56820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5682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PP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A4A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FE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5F3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AB7DC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A8AC6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1568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10"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          </a:t>
                      </a: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  <a:r>
                        <a:rPr lang="en-US" sz="800" b="1" i="0" u="none" strike="noStrike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             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17" name="ZoneTexte 16"/>
          <p:cNvSpPr txBox="1"/>
          <p:nvPr/>
        </p:nvSpPr>
        <p:spPr>
          <a:xfrm>
            <a:off x="722218" y="6204828"/>
            <a:ext cx="7848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Figure S1: </a:t>
            </a:r>
            <a:r>
              <a:rPr lang="en-GB" sz="1200" smtClean="0"/>
              <a:t>Six </a:t>
            </a:r>
            <a:r>
              <a:rPr lang="en-GB" sz="1200" dirty="0"/>
              <a:t>of nine metaplastic BCs were </a:t>
            </a:r>
            <a:r>
              <a:rPr lang="en-GB" sz="1200" dirty="0" err="1"/>
              <a:t>analyzed</a:t>
            </a:r>
            <a:r>
              <a:rPr lang="en-GB" sz="1200" dirty="0"/>
              <a:t> (3 recent metaplastic PDXs had not yet been engrafted)</a:t>
            </a:r>
            <a:r>
              <a:rPr lang="en-US" dirty="0"/>
              <a:t> </a:t>
            </a:r>
          </a:p>
        </p:txBody>
      </p:sp>
      <p:sp>
        <p:nvSpPr>
          <p:cNvPr id="4" name="Accolade fermante 3"/>
          <p:cNvSpPr/>
          <p:nvPr/>
        </p:nvSpPr>
        <p:spPr>
          <a:xfrm rot="5400000">
            <a:off x="2879813" y="2317511"/>
            <a:ext cx="360038" cy="3024337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ZoneTexte 6"/>
          <p:cNvSpPr txBox="1"/>
          <p:nvPr/>
        </p:nvSpPr>
        <p:spPr>
          <a:xfrm>
            <a:off x="1953558" y="4057327"/>
            <a:ext cx="2016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PI3K </a:t>
            </a:r>
            <a:r>
              <a:rPr lang="fr-FR" sz="1400" dirty="0" err="1"/>
              <a:t>pathway</a:t>
            </a:r>
            <a:r>
              <a:rPr lang="fr-FR" sz="1400" dirty="0"/>
              <a:t> ACTIVATED</a:t>
            </a:r>
            <a:endParaRPr lang="en-US" sz="1400" dirty="0"/>
          </a:p>
        </p:txBody>
      </p:sp>
      <p:sp>
        <p:nvSpPr>
          <p:cNvPr id="13" name="ZoneTexte 12"/>
          <p:cNvSpPr txBox="1"/>
          <p:nvPr/>
        </p:nvSpPr>
        <p:spPr>
          <a:xfrm>
            <a:off x="5356721" y="4072715"/>
            <a:ext cx="23762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PI3K </a:t>
            </a:r>
            <a:r>
              <a:rPr lang="fr-FR" sz="1200" dirty="0" err="1"/>
              <a:t>pathway</a:t>
            </a:r>
            <a:r>
              <a:rPr lang="fr-FR" sz="1200" dirty="0"/>
              <a:t> NON  ACTIVATED</a:t>
            </a:r>
            <a:endParaRPr lang="en-US" sz="1200" dirty="0"/>
          </a:p>
        </p:txBody>
      </p:sp>
      <p:sp>
        <p:nvSpPr>
          <p:cNvPr id="14" name="Accolade fermante 13"/>
          <p:cNvSpPr/>
          <p:nvPr/>
        </p:nvSpPr>
        <p:spPr>
          <a:xfrm rot="5400000">
            <a:off x="6080486" y="2141172"/>
            <a:ext cx="360038" cy="3377009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ZoneTexte 9"/>
          <p:cNvSpPr txBox="1"/>
          <p:nvPr/>
        </p:nvSpPr>
        <p:spPr>
          <a:xfrm>
            <a:off x="214701" y="841346"/>
            <a:ext cx="1260955" cy="3016210"/>
          </a:xfrm>
          <a:prstGeom prst="rect">
            <a:avLst/>
          </a:prstGeom>
          <a:noFill/>
          <a:ln w="0" cmpd="sng"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core RPPA</a:t>
            </a:r>
          </a:p>
          <a:p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I3-K-p110</a:t>
            </a:r>
          </a:p>
          <a:p>
            <a:pPr algn="r"/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er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hr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-4E-BP1</a:t>
            </a:r>
          </a:p>
          <a:p>
            <a:pPr algn="r"/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-p70-S6-kinase</a:t>
            </a:r>
          </a:p>
          <a:p>
            <a:pPr algn="r"/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-S6 Ribosomal</a:t>
            </a:r>
          </a:p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TEN</a:t>
            </a:r>
          </a:p>
          <a:p>
            <a:pPr algn="r"/>
            <a:endParaRPr 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IK3CA                                      PTEN                                    AKT1</a:t>
            </a:r>
          </a:p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ZoneTexte 17"/>
          <p:cNvSpPr txBox="1"/>
          <p:nvPr/>
        </p:nvSpPr>
        <p:spPr>
          <a:xfrm rot="16200000">
            <a:off x="-101116" y="3066189"/>
            <a:ext cx="13681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/>
              <a:t>Genomic</a:t>
            </a:r>
            <a:r>
              <a:rPr lang="fr-FR" sz="900" dirty="0"/>
              <a:t> </a:t>
            </a:r>
            <a:r>
              <a:rPr lang="fr-FR" sz="900" dirty="0" err="1"/>
              <a:t>alteration</a:t>
            </a:r>
            <a:endParaRPr lang="en-US" sz="900" dirty="0"/>
          </a:p>
        </p:txBody>
      </p:sp>
      <p:sp>
        <p:nvSpPr>
          <p:cNvPr id="19" name="Accolade ouvrante 18"/>
          <p:cNvSpPr/>
          <p:nvPr/>
        </p:nvSpPr>
        <p:spPr>
          <a:xfrm>
            <a:off x="827584" y="3073594"/>
            <a:ext cx="63975" cy="432048"/>
          </a:xfrm>
          <a:prstGeom prst="leftBrac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Organigramme : Connecteur 19"/>
          <p:cNvSpPr/>
          <p:nvPr/>
        </p:nvSpPr>
        <p:spPr>
          <a:xfrm>
            <a:off x="1763688" y="553314"/>
            <a:ext cx="72008" cy="72008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1" name="Organigramme : Connecteur 20"/>
          <p:cNvSpPr/>
          <p:nvPr/>
        </p:nvSpPr>
        <p:spPr>
          <a:xfrm>
            <a:off x="1979712" y="553314"/>
            <a:ext cx="72008" cy="72008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2" name="Organigramme : Connecteur 21"/>
          <p:cNvSpPr/>
          <p:nvPr/>
        </p:nvSpPr>
        <p:spPr>
          <a:xfrm>
            <a:off x="4348609" y="553314"/>
            <a:ext cx="72008" cy="72008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3" name="Organigramme : Connecteur 22"/>
          <p:cNvSpPr/>
          <p:nvPr/>
        </p:nvSpPr>
        <p:spPr>
          <a:xfrm>
            <a:off x="2908449" y="553314"/>
            <a:ext cx="72008" cy="72008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4" name="Organigramme : Connecteur 23"/>
          <p:cNvSpPr/>
          <p:nvPr/>
        </p:nvSpPr>
        <p:spPr>
          <a:xfrm>
            <a:off x="3203848" y="553314"/>
            <a:ext cx="72008" cy="72008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5" name="ZoneTexte 24"/>
          <p:cNvSpPr txBox="1"/>
          <p:nvPr/>
        </p:nvSpPr>
        <p:spPr>
          <a:xfrm>
            <a:off x="208657" y="481886"/>
            <a:ext cx="12596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err="1"/>
              <a:t>Metaplastic</a:t>
            </a:r>
            <a:r>
              <a:rPr lang="fr-FR" sz="1000" dirty="0"/>
              <a:t> </a:t>
            </a:r>
            <a:r>
              <a:rPr lang="fr-FR" sz="1000" dirty="0" err="1"/>
              <a:t>subtype</a:t>
            </a:r>
            <a:endParaRPr lang="en-US" sz="1000" dirty="0"/>
          </a:p>
        </p:txBody>
      </p:sp>
      <p:sp>
        <p:nvSpPr>
          <p:cNvPr id="26" name="ZoneTexte 25"/>
          <p:cNvSpPr txBox="1"/>
          <p:nvPr/>
        </p:nvSpPr>
        <p:spPr>
          <a:xfrm>
            <a:off x="112638" y="4052168"/>
            <a:ext cx="9664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b="1" dirty="0" err="1"/>
              <a:t>Proteogenomic</a:t>
            </a:r>
            <a:endParaRPr lang="en-US" sz="900" b="1" dirty="0"/>
          </a:p>
        </p:txBody>
      </p:sp>
      <p:sp>
        <p:nvSpPr>
          <p:cNvPr id="27" name="ZoneTexte 26"/>
          <p:cNvSpPr txBox="1"/>
          <p:nvPr/>
        </p:nvSpPr>
        <p:spPr>
          <a:xfrm>
            <a:off x="208657" y="116632"/>
            <a:ext cx="467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A</a:t>
            </a:r>
            <a:endParaRPr lang="en-US" dirty="0"/>
          </a:p>
        </p:txBody>
      </p:sp>
      <p:sp>
        <p:nvSpPr>
          <p:cNvPr id="28" name="ZoneTexte 27"/>
          <p:cNvSpPr txBox="1"/>
          <p:nvPr/>
        </p:nvSpPr>
        <p:spPr>
          <a:xfrm>
            <a:off x="179512" y="4365104"/>
            <a:ext cx="4675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B</a:t>
            </a:r>
            <a:endParaRPr lang="en-US" dirty="0"/>
          </a:p>
        </p:txBody>
      </p:sp>
      <p:graphicFrame>
        <p:nvGraphicFramePr>
          <p:cNvPr id="31" name="Tableau 3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856221"/>
              </p:ext>
            </p:extLst>
          </p:nvPr>
        </p:nvGraphicFramePr>
        <p:xfrm>
          <a:off x="1547684" y="764704"/>
          <a:ext cx="6305326" cy="2802255"/>
        </p:xfrm>
        <a:graphic>
          <a:graphicData uri="http://schemas.openxmlformats.org/drawingml/2006/table">
            <a:tbl>
              <a:tblPr/>
              <a:tblGrid>
                <a:gridCol w="103366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07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08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09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10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11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12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13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14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15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16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17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18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19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20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21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22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23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24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25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26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27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28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29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30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31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32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33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34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35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36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37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38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39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40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41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42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43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44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45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46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47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48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49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50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51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52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53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54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55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56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57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58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59"/>
                    </a:ext>
                  </a:extLst>
                </a:gridCol>
                <a:gridCol w="103366">
                  <a:extLst>
                    <a:ext uri="{9D8B030D-6E8A-4147-A177-3AD203B41FA5}">
                      <a16:colId xmlns="" xmlns:a16="http://schemas.microsoft.com/office/drawing/2014/main" val="20060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9CE9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ACE9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ACE9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1A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3D2A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3D2A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6D3A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8D4A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AD5A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BD5A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ED6A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0D7B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1D7B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1D7B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2D8B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4D8B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4D9B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D9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D9B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BDBB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DCB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DDCB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DDCB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FDDB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0DDB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5E0C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8E1C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8E1C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E1C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AE2C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CE3C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E3C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E3C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E4C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C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C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5C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5C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3E5C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6D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7E7D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7E7D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8E7D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DE9D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DE9D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1EBD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EBD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5ECD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7EDD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EE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CEFE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CEFE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FF0E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F2E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3F2E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4F3E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4F3E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FA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AF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A989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BC4C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D9D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3F6F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F8F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BD4D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BC4C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BD6D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DEE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AADA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EAE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7E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9FA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3DFF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7E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AB0B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EBE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CE5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A9FA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BD5D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BD4D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EDF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AA0A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E4E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EAE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EEF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6D6E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BCFD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DF1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AC2E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7F8F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DCD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7EDF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FD1E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9FA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DAD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EDCE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6EDF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8BACD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F4F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9FA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FC6E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F9F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8E3F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BE5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FE7F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4D5E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0E8F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EE7F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DAE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CFAF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BCEE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3C8E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3D4E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CE5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6995C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A1BCDF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6B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F8F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29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DF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BA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CD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CE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0E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1C7E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7D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8C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E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2E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B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AF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D9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67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3F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7F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FF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6E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1E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3C9E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DF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B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AF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DF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0C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DB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9D8E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BD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F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FDCE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8F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9D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DF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1E9F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EF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DF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E1F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C4E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DAE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D0E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EE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E0F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FA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DF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FF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6F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F1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F9F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2C8E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DF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EAF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1E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9EFF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B8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4F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AF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1E9F5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8CCE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9F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B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F9F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F2F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4C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8F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E5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EAF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9F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EF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2E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2F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E7F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BD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DFF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F6F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9F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0BBD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9D8E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7F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EBF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0E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DCE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9F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5CAE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CE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DAE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CE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1DEF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F1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F1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3F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0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DB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DAE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DF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3D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0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9EFF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B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8F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F4F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D9E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6F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AF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AA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E0F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9D8E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B1D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ACEE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7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F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DE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CEE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3A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6D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DC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2C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E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F4F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3A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6D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7D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F3F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8F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F9F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F6F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FA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8F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6A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2D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F2F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EC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3F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8E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D9E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EAF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DC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CC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5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FA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EC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EE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8CCE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8A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2F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E4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5EBF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7F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E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BE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6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DF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A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6CBE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ECF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6B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EBF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5E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E4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B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D9E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F3F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5ECF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DBE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F3F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4BEE0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5B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9EFF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B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9F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DD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CD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3E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1E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6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6EDF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E7F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9F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89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BD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F3F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E8F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8F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F9F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F0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3D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FA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4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C9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EBF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6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B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CE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7E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5F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3D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DE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F5F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E4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5CAE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5E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2D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E4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7F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7E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DE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F4F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E5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2E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1D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FA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E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0D2E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FA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F1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EF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8D7E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4BEE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B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F3F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DBE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EF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F1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B1D9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DD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4C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3E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5A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AD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99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1E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3C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1E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4C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FC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1D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AD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6B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CB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3C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DD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0F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E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DC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8E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49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B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F1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CE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E7F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B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AC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8F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F4F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7C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BB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F5F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B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F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3F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F1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DF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EAF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5E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DD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6F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7F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AD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F2F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FA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2C8E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ACDE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D8E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EA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7A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C1E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EF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2C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E4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F1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8FB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D1E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CE6F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E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E1F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C4E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8B6D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FE8F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ECF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3EAF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FF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CDD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D3E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DFF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5F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8F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A8A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D6D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C5C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1DDE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A7D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8C8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DF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2F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7E2F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D4D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CFE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6F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E6F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8E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4F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B6B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CE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FF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4EBF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FF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5E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BCB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FF3F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CE5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FA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B6D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CD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7F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CE5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BAB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D1D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CD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959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7E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4E0F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BDC0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3F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A7A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AF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A8A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AFB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848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919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3F6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126365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126365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126365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</a:tbl>
          </a:graphicData>
        </a:graphic>
      </p:graphicFrame>
      <p:graphicFrame>
        <p:nvGraphicFramePr>
          <p:cNvPr id="33" name="Tableau 3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47945264"/>
              </p:ext>
            </p:extLst>
          </p:nvPr>
        </p:nvGraphicFramePr>
        <p:xfrm>
          <a:off x="1564423" y="5229198"/>
          <a:ext cx="6281748" cy="855345"/>
        </p:xfrm>
        <a:graphic>
          <a:graphicData uri="http://schemas.openxmlformats.org/drawingml/2006/table">
            <a:tbl>
              <a:tblPr/>
              <a:tblGrid>
                <a:gridCol w="102839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11408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07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08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09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10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11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12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13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14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15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16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17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18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19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20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21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22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23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24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25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26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27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28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29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30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31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32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33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34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35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36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37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38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39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40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41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42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43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44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45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46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47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48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49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50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51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52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53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54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55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56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57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58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59"/>
                    </a:ext>
                  </a:extLst>
                </a:gridCol>
                <a:gridCol w="102839">
                  <a:extLst>
                    <a:ext uri="{9D8B030D-6E8A-4147-A177-3AD203B41FA5}">
                      <a16:colId xmlns="" xmlns:a16="http://schemas.microsoft.com/office/drawing/2014/main" val="20060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6A6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787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888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9EA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9FA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A2A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A6A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B1B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B5B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BAB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C2C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C2C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C5C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C7C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CDC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CED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D3D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D5D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D7D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8D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DEE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2E5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AE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BE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0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4F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AF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B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B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AFE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F9F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3F5F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5F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F2F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EF2F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3EAF6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FE7F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4F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1DDE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8D7E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7D7E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1D2EA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D1E9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CEE8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CCE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8CCE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8CCE7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0C7E4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C4E3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BC3E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BC3E2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C1E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DB9DD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B6DC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6B4DB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A1D1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A8AC6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35" name="Rectangle 34"/>
          <p:cNvSpPr/>
          <p:nvPr/>
        </p:nvSpPr>
        <p:spPr>
          <a:xfrm>
            <a:off x="827584" y="5229198"/>
            <a:ext cx="720079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-RSK2</a:t>
            </a:r>
          </a:p>
          <a:p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BRAF</a:t>
            </a:r>
          </a:p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KRAS</a:t>
            </a:r>
          </a:p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NF1</a:t>
            </a:r>
          </a:p>
        </p:txBody>
      </p:sp>
      <p:sp>
        <p:nvSpPr>
          <p:cNvPr id="36" name="ZoneTexte 35"/>
          <p:cNvSpPr txBox="1"/>
          <p:nvPr/>
        </p:nvSpPr>
        <p:spPr>
          <a:xfrm rot="16200000">
            <a:off x="-101117" y="5581835"/>
            <a:ext cx="136815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/>
              <a:t>Genomic</a:t>
            </a:r>
            <a:r>
              <a:rPr lang="fr-FR" sz="900" dirty="0"/>
              <a:t> </a:t>
            </a:r>
            <a:r>
              <a:rPr lang="fr-FR" sz="900" dirty="0" err="1"/>
              <a:t>alteration</a:t>
            </a:r>
            <a:endParaRPr lang="en-US" sz="900" dirty="0"/>
          </a:p>
        </p:txBody>
      </p:sp>
      <p:sp>
        <p:nvSpPr>
          <p:cNvPr id="37" name="Accolade ouvrante 36"/>
          <p:cNvSpPr/>
          <p:nvPr/>
        </p:nvSpPr>
        <p:spPr>
          <a:xfrm>
            <a:off x="835617" y="5589238"/>
            <a:ext cx="63975" cy="432048"/>
          </a:xfrm>
          <a:prstGeom prst="leftBrac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ZoneTexte 37"/>
          <p:cNvSpPr txBox="1"/>
          <p:nvPr/>
        </p:nvSpPr>
        <p:spPr>
          <a:xfrm>
            <a:off x="251520" y="4838961"/>
            <a:ext cx="12596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err="1"/>
              <a:t>Metaplastic</a:t>
            </a:r>
            <a:r>
              <a:rPr lang="fr-FR" sz="1000" dirty="0"/>
              <a:t> </a:t>
            </a:r>
            <a:r>
              <a:rPr lang="fr-FR" sz="1000" dirty="0" err="1"/>
              <a:t>subtype</a:t>
            </a:r>
            <a:endParaRPr lang="en-US" sz="1000" dirty="0"/>
          </a:p>
        </p:txBody>
      </p:sp>
      <p:sp>
        <p:nvSpPr>
          <p:cNvPr id="39" name="Organigramme : Connecteur 38"/>
          <p:cNvSpPr/>
          <p:nvPr/>
        </p:nvSpPr>
        <p:spPr>
          <a:xfrm>
            <a:off x="3491880" y="5013174"/>
            <a:ext cx="72008" cy="72008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40" name="Organigramme : Connecteur 39"/>
          <p:cNvSpPr/>
          <p:nvPr/>
        </p:nvSpPr>
        <p:spPr>
          <a:xfrm>
            <a:off x="3203848" y="5013174"/>
            <a:ext cx="72008" cy="72008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41" name="Organigramme : Connecteur 40"/>
          <p:cNvSpPr/>
          <p:nvPr/>
        </p:nvSpPr>
        <p:spPr>
          <a:xfrm>
            <a:off x="4355976" y="5013174"/>
            <a:ext cx="72008" cy="72008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42" name="Organigramme : Connecteur 41"/>
          <p:cNvSpPr/>
          <p:nvPr/>
        </p:nvSpPr>
        <p:spPr>
          <a:xfrm>
            <a:off x="4860032" y="5013174"/>
            <a:ext cx="72008" cy="72008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43" name="Organigramme : Connecteur 42"/>
          <p:cNvSpPr/>
          <p:nvPr/>
        </p:nvSpPr>
        <p:spPr>
          <a:xfrm>
            <a:off x="6732240" y="5013174"/>
            <a:ext cx="72008" cy="72008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44" name="Organigramme : Connecteur 43"/>
          <p:cNvSpPr/>
          <p:nvPr/>
        </p:nvSpPr>
        <p:spPr>
          <a:xfrm>
            <a:off x="2483768" y="548680"/>
            <a:ext cx="72008" cy="72008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45" name="Organigramme : Connecteur 44"/>
          <p:cNvSpPr/>
          <p:nvPr/>
        </p:nvSpPr>
        <p:spPr>
          <a:xfrm>
            <a:off x="4139952" y="5013176"/>
            <a:ext cx="72008" cy="72008"/>
          </a:xfrm>
          <a:prstGeom prst="flowChartConnector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5885636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 rtlCol="0" anchor="ctr"/>
      <a:lstStyle>
        <a:defPPr algn="ctr">
          <a:defRPr/>
        </a:defPPr>
      </a:lstStyle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sp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6C4EFE08936F84BB3906970EBF77DB3" ma:contentTypeVersion="7" ma:contentTypeDescription="Crée un document." ma:contentTypeScope="" ma:versionID="6bed2f95c7466c9830dced8ca3d92b81">
  <xsd:schema xmlns:xsd="http://www.w3.org/2001/XMLSchema" xmlns:xs="http://www.w3.org/2001/XMLSchema" xmlns:p="http://schemas.microsoft.com/office/2006/metadata/properties" xmlns:ns2="73992cc9-299d-4477-8b7d-ef6c6ce2669b" targetNamespace="http://schemas.microsoft.com/office/2006/metadata/properties" ma:root="true" ma:fieldsID="2ea760eeef4147d924151596e4a9086d" ns2:_="">
    <xsd:import namespace="73992cc9-299d-4477-8b7d-ef6c6ce2669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OCR" minOccurs="0"/>
                <xsd:element ref="ns2:MediaServiceDateTaken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3992cc9-299d-4477-8b7d-ef6c6ce2669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description="" ma:internalName="MediaServiceAutoTags" ma:readOnly="true">
      <xsd:simpleType>
        <xsd:restriction base="dms:Text"/>
      </xsd:simpleType>
    </xsd:element>
    <xsd:element name="MediaServiceOCR" ma:index="11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C9140051-084B-42CB-8A7D-8001D611D6DC}">
  <ds:schemaRefs>
    <ds:schemaRef ds:uri="http://purl.org/dc/terms/"/>
    <ds:schemaRef ds:uri="http://schemas.microsoft.com/office/2006/documentManagement/types"/>
    <ds:schemaRef ds:uri="73992cc9-299d-4477-8b7d-ef6c6ce2669b"/>
    <ds:schemaRef ds:uri="http://purl.org/dc/dcmitype/"/>
    <ds:schemaRef ds:uri="http://purl.org/dc/elements/1.1/"/>
    <ds:schemaRef ds:uri="http://schemas.microsoft.com/office/2006/metadata/properties"/>
    <ds:schemaRef ds:uri="http://schemas.openxmlformats.org/package/2006/metadata/core-properties"/>
    <ds:schemaRef ds:uri="http://www.w3.org/XML/1998/namespace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E72F236F-1701-47D0-96FB-7CB1F17AB8AE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E4A6E47-A197-4D41-873F-59DD5B0DDE4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3992cc9-299d-4477-8b7d-ef6c6ce2669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67</Words>
  <Application>Microsoft Office PowerPoint</Application>
  <PresentationFormat>Affichage à l'écran (4:3)</PresentationFormat>
  <Paragraphs>76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lorence</dc:creator>
  <cp:lastModifiedBy>Institut Curie</cp:lastModifiedBy>
  <cp:revision>20</cp:revision>
  <dcterms:created xsi:type="dcterms:W3CDTF">2019-07-30T15:30:41Z</dcterms:created>
  <dcterms:modified xsi:type="dcterms:W3CDTF">2019-11-21T13:04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6C4EFE08936F84BB3906970EBF77DB3</vt:lpwstr>
  </property>
</Properties>
</file>